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633319999677839E-2"/>
          <c:y val="2.4694216381315325E-2"/>
          <c:w val="0.89217377064143832"/>
          <c:h val="0.86871654944377508"/>
        </c:manualLayout>
      </c:layout>
      <c:scatterChart>
        <c:scatterStyle val="lineMarker"/>
        <c:varyColors val="0"/>
        <c:ser>
          <c:idx val="5"/>
          <c:order val="0"/>
          <c:tx>
            <c:strRef>
              <c:f>'[CT PSMA-101_Plasma-to-blood_ratio.xlsx]pbr'!$G$2</c:f>
              <c:strCache>
                <c:ptCount val="1"/>
                <c:pt idx="0">
                  <c:v>Patient A-01</c:v>
                </c:pt>
              </c:strCache>
            </c:strRef>
          </c:tx>
          <c:spPr>
            <a:ln w="19050" cap="rnd">
              <a:solidFill>
                <a:schemeClr val="tx1">
                  <a:alpha val="98000"/>
                </a:schemeClr>
              </a:solidFill>
              <a:round/>
            </a:ln>
            <a:effectLst/>
          </c:spPr>
          <c:marker>
            <c:symbol val="x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G$3:$G$172</c:f>
              <c:numCache>
                <c:formatCode>General</c:formatCode>
                <c:ptCount val="170"/>
                <c:pt idx="91">
                  <c:v>1.8253299999999999</c:v>
                </c:pt>
                <c:pt idx="92">
                  <c:v>1.8105500000000001</c:v>
                </c:pt>
                <c:pt idx="93">
                  <c:v>1.8298399999999999</c:v>
                </c:pt>
                <c:pt idx="94">
                  <c:v>1.81077</c:v>
                </c:pt>
                <c:pt idx="95">
                  <c:v>1.8011900000000001</c:v>
                </c:pt>
                <c:pt idx="96">
                  <c:v>1.8036700000000001</c:v>
                </c:pt>
                <c:pt idx="97">
                  <c:v>1.80911</c:v>
                </c:pt>
                <c:pt idx="98">
                  <c:v>1.8066899999999999</c:v>
                </c:pt>
                <c:pt idx="99">
                  <c:v>1.8001199999999999</c:v>
                </c:pt>
                <c:pt idx="100">
                  <c:v>1.8003199999999999</c:v>
                </c:pt>
                <c:pt idx="101">
                  <c:v>1.7935000000000001</c:v>
                </c:pt>
                <c:pt idx="102">
                  <c:v>1.7867500000000001</c:v>
                </c:pt>
                <c:pt idx="103">
                  <c:v>1.7898499999999999</c:v>
                </c:pt>
                <c:pt idx="104">
                  <c:v>1.7563299999999999</c:v>
                </c:pt>
                <c:pt idx="105">
                  <c:v>1.78254</c:v>
                </c:pt>
                <c:pt idx="106">
                  <c:v>1.7628600000000001</c:v>
                </c:pt>
                <c:pt idx="107">
                  <c:v>1.7741</c:v>
                </c:pt>
                <c:pt idx="108">
                  <c:v>1.8324100000000001</c:v>
                </c:pt>
                <c:pt idx="109">
                  <c:v>1.8083100000000001</c:v>
                </c:pt>
                <c:pt idx="110">
                  <c:v>1.82048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993-42BD-8B39-8E214C6B3FEE}"/>
            </c:ext>
          </c:extLst>
        </c:ser>
        <c:ser>
          <c:idx val="6"/>
          <c:order val="1"/>
          <c:tx>
            <c:strRef>
              <c:f>'[CT PSMA-101_Plasma-to-blood_ratio.xlsx]pbr'!$H$2</c:f>
              <c:strCache>
                <c:ptCount val="1"/>
                <c:pt idx="0">
                  <c:v>Patient A-02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H$3:$H$172</c:f>
              <c:numCache>
                <c:formatCode>General</c:formatCode>
                <c:ptCount val="170"/>
                <c:pt idx="111">
                  <c:v>1.8877600000000001</c:v>
                </c:pt>
                <c:pt idx="112">
                  <c:v>1.94614</c:v>
                </c:pt>
                <c:pt idx="113">
                  <c:v>1.95886</c:v>
                </c:pt>
                <c:pt idx="114">
                  <c:v>1.9487300000000001</c:v>
                </c:pt>
                <c:pt idx="115">
                  <c:v>1.9643200000000001</c:v>
                </c:pt>
                <c:pt idx="116">
                  <c:v>1.92624</c:v>
                </c:pt>
                <c:pt idx="117">
                  <c:v>1.95539</c:v>
                </c:pt>
                <c:pt idx="118">
                  <c:v>1.94154</c:v>
                </c:pt>
                <c:pt idx="119">
                  <c:v>1.97132</c:v>
                </c:pt>
                <c:pt idx="120">
                  <c:v>1.96811</c:v>
                </c:pt>
                <c:pt idx="121">
                  <c:v>1.9267099999999999</c:v>
                </c:pt>
                <c:pt idx="122">
                  <c:v>1.92397</c:v>
                </c:pt>
                <c:pt idx="123">
                  <c:v>1.93377</c:v>
                </c:pt>
                <c:pt idx="124">
                  <c:v>1.85341</c:v>
                </c:pt>
                <c:pt idx="125">
                  <c:v>1.81989</c:v>
                </c:pt>
                <c:pt idx="126">
                  <c:v>1.84439</c:v>
                </c:pt>
                <c:pt idx="127">
                  <c:v>1.88642</c:v>
                </c:pt>
                <c:pt idx="128">
                  <c:v>1.7630300000000001</c:v>
                </c:pt>
                <c:pt idx="129">
                  <c:v>1.890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993-42BD-8B39-8E214C6B3FEE}"/>
            </c:ext>
          </c:extLst>
        </c:ser>
        <c:ser>
          <c:idx val="7"/>
          <c:order val="2"/>
          <c:tx>
            <c:strRef>
              <c:f>'[CT PSMA-101_Plasma-to-blood_ratio.xlsx]pbr'!$I$2</c:f>
              <c:strCache>
                <c:ptCount val="1"/>
                <c:pt idx="0">
                  <c:v>Patient A-03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I$3:$I$172</c:f>
              <c:numCache>
                <c:formatCode>General</c:formatCode>
                <c:ptCount val="170"/>
                <c:pt idx="130">
                  <c:v>2</c:v>
                </c:pt>
                <c:pt idx="131">
                  <c:v>1.7928200000000001</c:v>
                </c:pt>
                <c:pt idx="132">
                  <c:v>1.75891</c:v>
                </c:pt>
                <c:pt idx="133">
                  <c:v>1.7595000000000001</c:v>
                </c:pt>
                <c:pt idx="134">
                  <c:v>1.7720499999999999</c:v>
                </c:pt>
                <c:pt idx="135">
                  <c:v>1.7765</c:v>
                </c:pt>
                <c:pt idx="136">
                  <c:v>1.7797400000000001</c:v>
                </c:pt>
                <c:pt idx="137">
                  <c:v>1.7976000000000001</c:v>
                </c:pt>
                <c:pt idx="138">
                  <c:v>1.7823800000000001</c:v>
                </c:pt>
                <c:pt idx="139">
                  <c:v>1.7843</c:v>
                </c:pt>
                <c:pt idx="140">
                  <c:v>1.74871</c:v>
                </c:pt>
                <c:pt idx="141">
                  <c:v>1.7553399999999999</c:v>
                </c:pt>
                <c:pt idx="142">
                  <c:v>1.7445900000000001</c:v>
                </c:pt>
                <c:pt idx="143">
                  <c:v>1.72855</c:v>
                </c:pt>
                <c:pt idx="144">
                  <c:v>1.72688</c:v>
                </c:pt>
                <c:pt idx="145">
                  <c:v>1.69235</c:v>
                </c:pt>
                <c:pt idx="146">
                  <c:v>1.7121200000000001</c:v>
                </c:pt>
                <c:pt idx="147">
                  <c:v>1.8108</c:v>
                </c:pt>
                <c:pt idx="148">
                  <c:v>1.74535</c:v>
                </c:pt>
                <c:pt idx="149">
                  <c:v>1.732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993-42BD-8B39-8E214C6B3FEE}"/>
            </c:ext>
          </c:extLst>
        </c:ser>
        <c:ser>
          <c:idx val="0"/>
          <c:order val="3"/>
          <c:tx>
            <c:strRef>
              <c:f>'[CT PSMA-101_Plasma-to-blood_ratio.xlsx]pbr'!$B$2</c:f>
              <c:strCache>
                <c:ptCount val="1"/>
                <c:pt idx="0">
                  <c:v>Patient B-01</c:v>
                </c:pt>
              </c:strCache>
            </c:strRef>
          </c:tx>
          <c:spPr>
            <a:ln w="19050" cap="rnd">
              <a:solidFill>
                <a:schemeClr val="bg1">
                  <a:lumMod val="65000"/>
                  <a:alpha val="97000"/>
                </a:schemeClr>
              </a:solidFill>
              <a:round/>
            </a:ln>
            <a:effectLst/>
          </c:spPr>
          <c:marker>
            <c:symbol val="x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B$3:$B$172</c:f>
              <c:numCache>
                <c:formatCode>General</c:formatCode>
                <c:ptCount val="170"/>
                <c:pt idx="0">
                  <c:v>0</c:v>
                </c:pt>
                <c:pt idx="1">
                  <c:v>1.5448599999999999</c:v>
                </c:pt>
                <c:pt idx="2">
                  <c:v>1.54972</c:v>
                </c:pt>
                <c:pt idx="3">
                  <c:v>1.5567</c:v>
                </c:pt>
                <c:pt idx="4">
                  <c:v>1.5505</c:v>
                </c:pt>
                <c:pt idx="5">
                  <c:v>1.60981</c:v>
                </c:pt>
                <c:pt idx="6">
                  <c:v>1.5628899999999999</c:v>
                </c:pt>
                <c:pt idx="7">
                  <c:v>1.55914</c:v>
                </c:pt>
                <c:pt idx="8">
                  <c:v>1.5586899999999999</c:v>
                </c:pt>
                <c:pt idx="9">
                  <c:v>1.63246</c:v>
                </c:pt>
                <c:pt idx="10">
                  <c:v>1.59383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993-42BD-8B39-8E214C6B3FEE}"/>
            </c:ext>
          </c:extLst>
        </c:ser>
        <c:ser>
          <c:idx val="3"/>
          <c:order val="4"/>
          <c:tx>
            <c:strRef>
              <c:f>'[CT PSMA-101_Plasma-to-blood_ratio.xlsx]pbr'!$E$2</c:f>
              <c:strCache>
                <c:ptCount val="1"/>
                <c:pt idx="0">
                  <c:v>Patient B-02</c:v>
                </c:pt>
              </c:strCache>
            </c:strRef>
          </c:tx>
          <c:spPr>
            <a:ln w="19050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E$3:$E$172</c:f>
              <c:numCache>
                <c:formatCode>General</c:formatCode>
                <c:ptCount val="170"/>
                <c:pt idx="51">
                  <c:v>1.5</c:v>
                </c:pt>
                <c:pt idx="52">
                  <c:v>1.6812499999999999</c:v>
                </c:pt>
                <c:pt idx="53">
                  <c:v>1.6859900000000001</c:v>
                </c:pt>
                <c:pt idx="54">
                  <c:v>1.6603399999999999</c:v>
                </c:pt>
                <c:pt idx="55">
                  <c:v>1.66018</c:v>
                </c:pt>
                <c:pt idx="56">
                  <c:v>1.66222</c:v>
                </c:pt>
                <c:pt idx="57">
                  <c:v>1.6520900000000001</c:v>
                </c:pt>
                <c:pt idx="58">
                  <c:v>1.64218</c:v>
                </c:pt>
                <c:pt idx="59">
                  <c:v>1.62754</c:v>
                </c:pt>
                <c:pt idx="60">
                  <c:v>1.6272599999999999</c:v>
                </c:pt>
                <c:pt idx="61">
                  <c:v>1.63402</c:v>
                </c:pt>
                <c:pt idx="62">
                  <c:v>1.62422</c:v>
                </c:pt>
                <c:pt idx="63">
                  <c:v>1.60154</c:v>
                </c:pt>
                <c:pt idx="64">
                  <c:v>1.63087</c:v>
                </c:pt>
                <c:pt idx="65">
                  <c:v>1.6119399999999999</c:v>
                </c:pt>
                <c:pt idx="66">
                  <c:v>1.6024799999999999</c:v>
                </c:pt>
                <c:pt idx="67">
                  <c:v>1.6143000000000001</c:v>
                </c:pt>
                <c:pt idx="68">
                  <c:v>1.6565300000000001</c:v>
                </c:pt>
                <c:pt idx="69">
                  <c:v>1.68889</c:v>
                </c:pt>
                <c:pt idx="70">
                  <c:v>1.54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993-42BD-8B39-8E214C6B3FEE}"/>
            </c:ext>
          </c:extLst>
        </c:ser>
        <c:ser>
          <c:idx val="8"/>
          <c:order val="5"/>
          <c:tx>
            <c:strRef>
              <c:f>'[CT PSMA-101_Plasma-to-blood_ratio.xlsx]pbr'!$J$2</c:f>
              <c:strCache>
                <c:ptCount val="1"/>
                <c:pt idx="0">
                  <c:v>Patient B-03</c:v>
                </c:pt>
              </c:strCache>
            </c:strRef>
          </c:tx>
          <c:spPr>
            <a:ln w="19050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J$3:$J$172</c:f>
              <c:numCache>
                <c:formatCode>General</c:formatCode>
                <c:ptCount val="170"/>
                <c:pt idx="150">
                  <c:v>0</c:v>
                </c:pt>
                <c:pt idx="151">
                  <c:v>0</c:v>
                </c:pt>
                <c:pt idx="152">
                  <c:v>1.7643200000000001</c:v>
                </c:pt>
                <c:pt idx="153">
                  <c:v>1.7687200000000001</c:v>
                </c:pt>
                <c:pt idx="154">
                  <c:v>1.7596000000000001</c:v>
                </c:pt>
                <c:pt idx="155">
                  <c:v>1.75796</c:v>
                </c:pt>
                <c:pt idx="156">
                  <c:v>1.7557799999999999</c:v>
                </c:pt>
                <c:pt idx="157">
                  <c:v>1.7588999999999999</c:v>
                </c:pt>
                <c:pt idx="158">
                  <c:v>1.7573300000000001</c:v>
                </c:pt>
                <c:pt idx="159">
                  <c:v>1.7268399999999999</c:v>
                </c:pt>
                <c:pt idx="160">
                  <c:v>1.70021</c:v>
                </c:pt>
                <c:pt idx="161">
                  <c:v>1.7436400000000001</c:v>
                </c:pt>
                <c:pt idx="162">
                  <c:v>1.62199</c:v>
                </c:pt>
                <c:pt idx="163">
                  <c:v>1.7036100000000001</c:v>
                </c:pt>
                <c:pt idx="164">
                  <c:v>1.6832400000000001</c:v>
                </c:pt>
                <c:pt idx="165">
                  <c:v>1.6481399999999999</c:v>
                </c:pt>
                <c:pt idx="166">
                  <c:v>1.58399</c:v>
                </c:pt>
                <c:pt idx="167">
                  <c:v>1.7761499999999999</c:v>
                </c:pt>
                <c:pt idx="168">
                  <c:v>1.74142</c:v>
                </c:pt>
                <c:pt idx="169">
                  <c:v>1.511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993-42BD-8B39-8E214C6B3FEE}"/>
            </c:ext>
          </c:extLst>
        </c:ser>
        <c:ser>
          <c:idx val="1"/>
          <c:order val="6"/>
          <c:tx>
            <c:strRef>
              <c:f>'[CT PSMA-101_Plasma-to-blood_ratio.xlsx]pbr'!$C$2</c:f>
              <c:strCache>
                <c:ptCount val="1"/>
                <c:pt idx="0">
                  <c:v>Patient C-02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C$3:$C$172</c:f>
              <c:numCache>
                <c:formatCode>General</c:formatCode>
                <c:ptCount val="170"/>
                <c:pt idx="11">
                  <c:v>1</c:v>
                </c:pt>
                <c:pt idx="12">
                  <c:v>1.73333</c:v>
                </c:pt>
                <c:pt idx="13">
                  <c:v>1.5107200000000001</c:v>
                </c:pt>
                <c:pt idx="14">
                  <c:v>1.4997400000000001</c:v>
                </c:pt>
                <c:pt idx="15">
                  <c:v>1.51969</c:v>
                </c:pt>
                <c:pt idx="16">
                  <c:v>1.5197499999999999</c:v>
                </c:pt>
                <c:pt idx="17">
                  <c:v>1.5183</c:v>
                </c:pt>
                <c:pt idx="18">
                  <c:v>1.5261100000000001</c:v>
                </c:pt>
                <c:pt idx="19">
                  <c:v>1.51945</c:v>
                </c:pt>
                <c:pt idx="20">
                  <c:v>1.51572</c:v>
                </c:pt>
                <c:pt idx="21">
                  <c:v>1.5319100000000001</c:v>
                </c:pt>
                <c:pt idx="22">
                  <c:v>1.4953700000000001</c:v>
                </c:pt>
                <c:pt idx="23">
                  <c:v>1.4913099999999999</c:v>
                </c:pt>
                <c:pt idx="24">
                  <c:v>1.46794</c:v>
                </c:pt>
                <c:pt idx="25">
                  <c:v>1.48125</c:v>
                </c:pt>
                <c:pt idx="26">
                  <c:v>1.48837</c:v>
                </c:pt>
                <c:pt idx="27">
                  <c:v>1.4791700000000001</c:v>
                </c:pt>
                <c:pt idx="28">
                  <c:v>1.4904599999999999</c:v>
                </c:pt>
                <c:pt idx="29">
                  <c:v>1.55816</c:v>
                </c:pt>
                <c:pt idx="30">
                  <c:v>1.464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B993-42BD-8B39-8E214C6B3FEE}"/>
            </c:ext>
          </c:extLst>
        </c:ser>
        <c:ser>
          <c:idx val="2"/>
          <c:order val="7"/>
          <c:tx>
            <c:strRef>
              <c:f>'[CT PSMA-101_Plasma-to-blood_ratio.xlsx]pbr'!$D$2</c:f>
              <c:strCache>
                <c:ptCount val="1"/>
                <c:pt idx="0">
                  <c:v>Patient C-03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triangl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D$3:$D$172</c:f>
              <c:numCache>
                <c:formatCode>General</c:formatCode>
                <c:ptCount val="170"/>
                <c:pt idx="31">
                  <c:v>0</c:v>
                </c:pt>
                <c:pt idx="32">
                  <c:v>1.70255</c:v>
                </c:pt>
                <c:pt idx="33">
                  <c:v>1.6850000000000001</c:v>
                </c:pt>
                <c:pt idx="34">
                  <c:v>1.6918200000000001</c:v>
                </c:pt>
                <c:pt idx="35">
                  <c:v>1.6935100000000001</c:v>
                </c:pt>
                <c:pt idx="36">
                  <c:v>1.67818</c:v>
                </c:pt>
                <c:pt idx="37">
                  <c:v>1.6933199999999999</c:v>
                </c:pt>
                <c:pt idx="38">
                  <c:v>1.68458</c:v>
                </c:pt>
                <c:pt idx="39">
                  <c:v>1.6853800000000001</c:v>
                </c:pt>
                <c:pt idx="40">
                  <c:v>1.6835800000000001</c:v>
                </c:pt>
                <c:pt idx="41">
                  <c:v>1.65062</c:v>
                </c:pt>
                <c:pt idx="42">
                  <c:v>1.66049</c:v>
                </c:pt>
                <c:pt idx="43">
                  <c:v>1.6494</c:v>
                </c:pt>
                <c:pt idx="44">
                  <c:v>1.6735</c:v>
                </c:pt>
                <c:pt idx="45">
                  <c:v>1.6429199999999999</c:v>
                </c:pt>
                <c:pt idx="46">
                  <c:v>1.65967</c:v>
                </c:pt>
                <c:pt idx="47">
                  <c:v>1.6507700000000001</c:v>
                </c:pt>
                <c:pt idx="48">
                  <c:v>1.7007000000000001</c:v>
                </c:pt>
                <c:pt idx="49">
                  <c:v>1.6653100000000001</c:v>
                </c:pt>
                <c:pt idx="50">
                  <c:v>1.60861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B993-42BD-8B39-8E214C6B3FEE}"/>
            </c:ext>
          </c:extLst>
        </c:ser>
        <c:ser>
          <c:idx val="4"/>
          <c:order val="8"/>
          <c:tx>
            <c:strRef>
              <c:f>'[CT PSMA-101_Plasma-to-blood_ratio.xlsx]pbr'!$F$2</c:f>
              <c:strCache>
                <c:ptCount val="1"/>
                <c:pt idx="0">
                  <c:v>Patient C-04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diamond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[CT PSMA-101_Plasma-to-blood_ratio.xlsx]pbr'!$A$3:$A$172</c:f>
              <c:numCache>
                <c:formatCode>General</c:formatCode>
                <c:ptCount val="170"/>
                <c:pt idx="0">
                  <c:v>0.58299999999999996</c:v>
                </c:pt>
                <c:pt idx="1">
                  <c:v>1.55</c:v>
                </c:pt>
                <c:pt idx="2">
                  <c:v>2.3170000000000002</c:v>
                </c:pt>
                <c:pt idx="3">
                  <c:v>3.0169999999999999</c:v>
                </c:pt>
                <c:pt idx="4">
                  <c:v>3.6669999999999998</c:v>
                </c:pt>
                <c:pt idx="5">
                  <c:v>24.582999999999998</c:v>
                </c:pt>
                <c:pt idx="6">
                  <c:v>29.567</c:v>
                </c:pt>
                <c:pt idx="7">
                  <c:v>39.533000000000001</c:v>
                </c:pt>
                <c:pt idx="8">
                  <c:v>53.767000000000003</c:v>
                </c:pt>
                <c:pt idx="9">
                  <c:v>62.5</c:v>
                </c:pt>
                <c:pt idx="10">
                  <c:v>119.983</c:v>
                </c:pt>
                <c:pt idx="11">
                  <c:v>0.33300000000000002</c:v>
                </c:pt>
                <c:pt idx="12">
                  <c:v>0.66700000000000004</c:v>
                </c:pt>
                <c:pt idx="13">
                  <c:v>1</c:v>
                </c:pt>
                <c:pt idx="14">
                  <c:v>1.3169999999999999</c:v>
                </c:pt>
                <c:pt idx="15">
                  <c:v>1.65</c:v>
                </c:pt>
                <c:pt idx="16">
                  <c:v>2</c:v>
                </c:pt>
                <c:pt idx="17">
                  <c:v>2.3170000000000002</c:v>
                </c:pt>
                <c:pt idx="18">
                  <c:v>2.6669999999999998</c:v>
                </c:pt>
                <c:pt idx="19">
                  <c:v>3</c:v>
                </c:pt>
                <c:pt idx="20">
                  <c:v>3.9830000000000001</c:v>
                </c:pt>
                <c:pt idx="21">
                  <c:v>5.05</c:v>
                </c:pt>
                <c:pt idx="22">
                  <c:v>7.383</c:v>
                </c:pt>
                <c:pt idx="23">
                  <c:v>9.7669999999999995</c:v>
                </c:pt>
                <c:pt idx="24">
                  <c:v>14.6</c:v>
                </c:pt>
                <c:pt idx="25">
                  <c:v>19.75</c:v>
                </c:pt>
                <c:pt idx="26">
                  <c:v>29.6</c:v>
                </c:pt>
                <c:pt idx="27">
                  <c:v>39.732999999999997</c:v>
                </c:pt>
                <c:pt idx="28">
                  <c:v>49.616999999999997</c:v>
                </c:pt>
                <c:pt idx="29">
                  <c:v>59.8</c:v>
                </c:pt>
                <c:pt idx="30">
                  <c:v>120.9</c:v>
                </c:pt>
                <c:pt idx="31">
                  <c:v>0.33300000000000002</c:v>
                </c:pt>
                <c:pt idx="32">
                  <c:v>0.66700000000000004</c:v>
                </c:pt>
                <c:pt idx="33">
                  <c:v>1</c:v>
                </c:pt>
                <c:pt idx="34">
                  <c:v>1.3169999999999999</c:v>
                </c:pt>
                <c:pt idx="35">
                  <c:v>1.667</c:v>
                </c:pt>
                <c:pt idx="36">
                  <c:v>1.9830000000000001</c:v>
                </c:pt>
                <c:pt idx="37">
                  <c:v>2.3330000000000002</c:v>
                </c:pt>
                <c:pt idx="38">
                  <c:v>2.6829999999999998</c:v>
                </c:pt>
                <c:pt idx="39">
                  <c:v>2.9830000000000001</c:v>
                </c:pt>
                <c:pt idx="40">
                  <c:v>3.35</c:v>
                </c:pt>
                <c:pt idx="41">
                  <c:v>5.0830000000000002</c:v>
                </c:pt>
                <c:pt idx="42">
                  <c:v>7.4329999999999998</c:v>
                </c:pt>
                <c:pt idx="43">
                  <c:v>10.15</c:v>
                </c:pt>
                <c:pt idx="44">
                  <c:v>14.6</c:v>
                </c:pt>
                <c:pt idx="45">
                  <c:v>20.067</c:v>
                </c:pt>
                <c:pt idx="46">
                  <c:v>29.65</c:v>
                </c:pt>
                <c:pt idx="47">
                  <c:v>39.917000000000002</c:v>
                </c:pt>
                <c:pt idx="48">
                  <c:v>49.966999999999999</c:v>
                </c:pt>
                <c:pt idx="49">
                  <c:v>59.517000000000003</c:v>
                </c:pt>
                <c:pt idx="50">
                  <c:v>121.18300000000001</c:v>
                </c:pt>
                <c:pt idx="51">
                  <c:v>0.4</c:v>
                </c:pt>
                <c:pt idx="52">
                  <c:v>0.68300000000000005</c:v>
                </c:pt>
                <c:pt idx="53">
                  <c:v>1.333</c:v>
                </c:pt>
                <c:pt idx="54">
                  <c:v>1.667</c:v>
                </c:pt>
                <c:pt idx="55">
                  <c:v>2</c:v>
                </c:pt>
                <c:pt idx="56">
                  <c:v>2.3330000000000002</c:v>
                </c:pt>
                <c:pt idx="57">
                  <c:v>2.6669999999999998</c:v>
                </c:pt>
                <c:pt idx="58">
                  <c:v>2.9830000000000001</c:v>
                </c:pt>
                <c:pt idx="59">
                  <c:v>4</c:v>
                </c:pt>
                <c:pt idx="60">
                  <c:v>5.0330000000000004</c:v>
                </c:pt>
                <c:pt idx="61">
                  <c:v>7.45</c:v>
                </c:pt>
                <c:pt idx="62">
                  <c:v>10.25</c:v>
                </c:pt>
                <c:pt idx="63">
                  <c:v>14.782999999999999</c:v>
                </c:pt>
                <c:pt idx="64">
                  <c:v>19.399999999999999</c:v>
                </c:pt>
                <c:pt idx="65">
                  <c:v>29.483000000000001</c:v>
                </c:pt>
                <c:pt idx="66">
                  <c:v>40.15</c:v>
                </c:pt>
                <c:pt idx="67">
                  <c:v>49.3</c:v>
                </c:pt>
                <c:pt idx="68">
                  <c:v>60.4</c:v>
                </c:pt>
                <c:pt idx="69">
                  <c:v>69.400000000000006</c:v>
                </c:pt>
                <c:pt idx="70">
                  <c:v>120.43300000000001</c:v>
                </c:pt>
                <c:pt idx="71">
                  <c:v>0.33300000000000002</c:v>
                </c:pt>
                <c:pt idx="72">
                  <c:v>0.66700000000000004</c:v>
                </c:pt>
                <c:pt idx="73">
                  <c:v>0.98299999999999998</c:v>
                </c:pt>
                <c:pt idx="74">
                  <c:v>1.3169999999999999</c:v>
                </c:pt>
                <c:pt idx="75">
                  <c:v>1.667</c:v>
                </c:pt>
                <c:pt idx="76">
                  <c:v>1.9830000000000001</c:v>
                </c:pt>
                <c:pt idx="77">
                  <c:v>2.3170000000000002</c:v>
                </c:pt>
                <c:pt idx="78">
                  <c:v>2.65</c:v>
                </c:pt>
                <c:pt idx="79">
                  <c:v>2.9830000000000001</c:v>
                </c:pt>
                <c:pt idx="80">
                  <c:v>4.2169999999999996</c:v>
                </c:pt>
                <c:pt idx="81">
                  <c:v>5.3170000000000002</c:v>
                </c:pt>
                <c:pt idx="82">
                  <c:v>7.4329999999999998</c:v>
                </c:pt>
                <c:pt idx="83">
                  <c:v>9.8170000000000002</c:v>
                </c:pt>
                <c:pt idx="84">
                  <c:v>14.7</c:v>
                </c:pt>
                <c:pt idx="85">
                  <c:v>19.783000000000001</c:v>
                </c:pt>
                <c:pt idx="86">
                  <c:v>29.933</c:v>
                </c:pt>
                <c:pt idx="87">
                  <c:v>40.549999999999997</c:v>
                </c:pt>
                <c:pt idx="88">
                  <c:v>51.567</c:v>
                </c:pt>
                <c:pt idx="89">
                  <c:v>59.616999999999997</c:v>
                </c:pt>
                <c:pt idx="90">
                  <c:v>122.983</c:v>
                </c:pt>
                <c:pt idx="91">
                  <c:v>0.46700000000000003</c:v>
                </c:pt>
                <c:pt idx="92">
                  <c:v>0.8</c:v>
                </c:pt>
                <c:pt idx="93">
                  <c:v>1.0669999999999999</c:v>
                </c:pt>
                <c:pt idx="94">
                  <c:v>1.583</c:v>
                </c:pt>
                <c:pt idx="95">
                  <c:v>1.9830000000000001</c:v>
                </c:pt>
                <c:pt idx="96">
                  <c:v>2.367</c:v>
                </c:pt>
                <c:pt idx="97">
                  <c:v>2.7330000000000001</c:v>
                </c:pt>
                <c:pt idx="98">
                  <c:v>3.0830000000000002</c:v>
                </c:pt>
                <c:pt idx="99">
                  <c:v>3.4169999999999998</c:v>
                </c:pt>
                <c:pt idx="100">
                  <c:v>3.9830000000000001</c:v>
                </c:pt>
                <c:pt idx="101">
                  <c:v>5.0170000000000003</c:v>
                </c:pt>
                <c:pt idx="102">
                  <c:v>7.4669999999999996</c:v>
                </c:pt>
                <c:pt idx="103">
                  <c:v>9.6999999999999993</c:v>
                </c:pt>
                <c:pt idx="104">
                  <c:v>15.1</c:v>
                </c:pt>
                <c:pt idx="105">
                  <c:v>19.75</c:v>
                </c:pt>
                <c:pt idx="106">
                  <c:v>29.183</c:v>
                </c:pt>
                <c:pt idx="107">
                  <c:v>39.466999999999999</c:v>
                </c:pt>
                <c:pt idx="108">
                  <c:v>54.25</c:v>
                </c:pt>
                <c:pt idx="109">
                  <c:v>60.232999999999997</c:v>
                </c:pt>
                <c:pt idx="110">
                  <c:v>122.467</c:v>
                </c:pt>
                <c:pt idx="111">
                  <c:v>2</c:v>
                </c:pt>
                <c:pt idx="112">
                  <c:v>2.5830000000000002</c:v>
                </c:pt>
                <c:pt idx="113">
                  <c:v>2.9</c:v>
                </c:pt>
                <c:pt idx="114">
                  <c:v>3.2170000000000001</c:v>
                </c:pt>
                <c:pt idx="115">
                  <c:v>3.5</c:v>
                </c:pt>
                <c:pt idx="116">
                  <c:v>3.883</c:v>
                </c:pt>
                <c:pt idx="117">
                  <c:v>4.2</c:v>
                </c:pt>
                <c:pt idx="118">
                  <c:v>4.5170000000000003</c:v>
                </c:pt>
                <c:pt idx="119">
                  <c:v>4.867</c:v>
                </c:pt>
                <c:pt idx="120">
                  <c:v>5.5170000000000003</c:v>
                </c:pt>
                <c:pt idx="121">
                  <c:v>8</c:v>
                </c:pt>
                <c:pt idx="122">
                  <c:v>10.532999999999999</c:v>
                </c:pt>
                <c:pt idx="123">
                  <c:v>15.167</c:v>
                </c:pt>
                <c:pt idx="124">
                  <c:v>20.350000000000001</c:v>
                </c:pt>
                <c:pt idx="125">
                  <c:v>29.4</c:v>
                </c:pt>
                <c:pt idx="126">
                  <c:v>40.783000000000001</c:v>
                </c:pt>
                <c:pt idx="127">
                  <c:v>49.716999999999999</c:v>
                </c:pt>
                <c:pt idx="128">
                  <c:v>58.167000000000002</c:v>
                </c:pt>
                <c:pt idx="129">
                  <c:v>136.083</c:v>
                </c:pt>
                <c:pt idx="130">
                  <c:v>0.317</c:v>
                </c:pt>
                <c:pt idx="131">
                  <c:v>0.65</c:v>
                </c:pt>
                <c:pt idx="132">
                  <c:v>0.98299999999999998</c:v>
                </c:pt>
                <c:pt idx="133">
                  <c:v>1.3169999999999999</c:v>
                </c:pt>
                <c:pt idx="134">
                  <c:v>1.667</c:v>
                </c:pt>
                <c:pt idx="135">
                  <c:v>1.9830000000000001</c:v>
                </c:pt>
                <c:pt idx="136">
                  <c:v>2.3330000000000002</c:v>
                </c:pt>
                <c:pt idx="137">
                  <c:v>2.6669999999999998</c:v>
                </c:pt>
                <c:pt idx="138">
                  <c:v>3.0169999999999999</c:v>
                </c:pt>
                <c:pt idx="139">
                  <c:v>3.9</c:v>
                </c:pt>
                <c:pt idx="140">
                  <c:v>4.8499999999999996</c:v>
                </c:pt>
                <c:pt idx="141">
                  <c:v>7.383</c:v>
                </c:pt>
                <c:pt idx="142">
                  <c:v>9.7829999999999995</c:v>
                </c:pt>
                <c:pt idx="143">
                  <c:v>14.532999999999999</c:v>
                </c:pt>
                <c:pt idx="144">
                  <c:v>19.533000000000001</c:v>
                </c:pt>
                <c:pt idx="145">
                  <c:v>29.516999999999999</c:v>
                </c:pt>
                <c:pt idx="146">
                  <c:v>39.6</c:v>
                </c:pt>
                <c:pt idx="147">
                  <c:v>52.716999999999999</c:v>
                </c:pt>
                <c:pt idx="148">
                  <c:v>58.567</c:v>
                </c:pt>
                <c:pt idx="149">
                  <c:v>122.267</c:v>
                </c:pt>
                <c:pt idx="150">
                  <c:v>0.33300000000000002</c:v>
                </c:pt>
                <c:pt idx="151">
                  <c:v>0.66700000000000004</c:v>
                </c:pt>
                <c:pt idx="152">
                  <c:v>1.0169999999999999</c:v>
                </c:pt>
                <c:pt idx="153">
                  <c:v>1.35</c:v>
                </c:pt>
                <c:pt idx="154">
                  <c:v>1.6830000000000001</c:v>
                </c:pt>
                <c:pt idx="155">
                  <c:v>2.0329999999999999</c:v>
                </c:pt>
                <c:pt idx="156">
                  <c:v>2.367</c:v>
                </c:pt>
                <c:pt idx="157">
                  <c:v>2.7170000000000001</c:v>
                </c:pt>
                <c:pt idx="158">
                  <c:v>2.9830000000000001</c:v>
                </c:pt>
                <c:pt idx="159">
                  <c:v>3.9169999999999998</c:v>
                </c:pt>
                <c:pt idx="160">
                  <c:v>4.867</c:v>
                </c:pt>
                <c:pt idx="161">
                  <c:v>7.15</c:v>
                </c:pt>
                <c:pt idx="162">
                  <c:v>9.4499999999999993</c:v>
                </c:pt>
                <c:pt idx="163">
                  <c:v>14.583</c:v>
                </c:pt>
                <c:pt idx="164">
                  <c:v>19.600000000000001</c:v>
                </c:pt>
                <c:pt idx="165">
                  <c:v>29.8</c:v>
                </c:pt>
                <c:pt idx="166">
                  <c:v>39.832999999999998</c:v>
                </c:pt>
                <c:pt idx="167">
                  <c:v>50.082999999999998</c:v>
                </c:pt>
                <c:pt idx="168">
                  <c:v>60.582999999999998</c:v>
                </c:pt>
                <c:pt idx="169">
                  <c:v>123.18300000000001</c:v>
                </c:pt>
              </c:numCache>
            </c:numRef>
          </c:xVal>
          <c:yVal>
            <c:numRef>
              <c:f>'[CT PSMA-101_Plasma-to-blood_ratio.xlsx]pbr'!$F$3:$F$172</c:f>
              <c:numCache>
                <c:formatCode>General</c:formatCode>
                <c:ptCount val="170"/>
                <c:pt idx="71">
                  <c:v>0</c:v>
                </c:pt>
                <c:pt idx="72">
                  <c:v>0</c:v>
                </c:pt>
                <c:pt idx="73">
                  <c:v>1.5227299999999999</c:v>
                </c:pt>
                <c:pt idx="74">
                  <c:v>1.56219</c:v>
                </c:pt>
                <c:pt idx="75">
                  <c:v>1.5682499999999999</c:v>
                </c:pt>
                <c:pt idx="76">
                  <c:v>1.57145</c:v>
                </c:pt>
                <c:pt idx="77">
                  <c:v>1.55376</c:v>
                </c:pt>
                <c:pt idx="78">
                  <c:v>1.55307</c:v>
                </c:pt>
                <c:pt idx="79">
                  <c:v>1.5486</c:v>
                </c:pt>
                <c:pt idx="80">
                  <c:v>1.4613</c:v>
                </c:pt>
                <c:pt idx="81">
                  <c:v>1.4663299999999999</c:v>
                </c:pt>
                <c:pt idx="82">
                  <c:v>1.5423199999999999</c:v>
                </c:pt>
                <c:pt idx="83">
                  <c:v>1.5176499999999999</c:v>
                </c:pt>
                <c:pt idx="84">
                  <c:v>1.50007</c:v>
                </c:pt>
                <c:pt idx="85">
                  <c:v>1.52929</c:v>
                </c:pt>
                <c:pt idx="86">
                  <c:v>1.5255799999999999</c:v>
                </c:pt>
                <c:pt idx="87">
                  <c:v>1.5239100000000001</c:v>
                </c:pt>
                <c:pt idx="88">
                  <c:v>1.6096200000000001</c:v>
                </c:pt>
                <c:pt idx="89">
                  <c:v>1.5988800000000001</c:v>
                </c:pt>
                <c:pt idx="90">
                  <c:v>1.54787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993-42BD-8B39-8E214C6B3F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2156608"/>
        <c:axId val="349090400"/>
      </c:scatterChart>
      <c:valAx>
        <c:axId val="3021566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solidFill>
                      <a:sysClr val="windowText" lastClr="000000"/>
                    </a:solidFill>
                  </a:rPr>
                  <a:t>Time (minute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349090400"/>
        <c:crosses val="autoZero"/>
        <c:crossBetween val="midCat"/>
        <c:majorUnit val="10"/>
      </c:valAx>
      <c:valAx>
        <c:axId val="3490904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>
                    <a:solidFill>
                      <a:sysClr val="windowText" lastClr="000000"/>
                    </a:solidFill>
                  </a:rPr>
                  <a:t>Plasma-to-blood ratio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302156608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105375875246865"/>
          <c:y val="0.51204427834594202"/>
          <c:w val="0.72339962576277006"/>
          <c:h val="0.145415522459158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FI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I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BED6E-64A9-4539-94EE-1666D4028C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D9E6C5-5F1C-4F14-A3FC-66872152ED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8482E-A429-46AA-B6F9-BD7D887B0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C100E2-6EA0-41E7-AAA0-5F5C78AD7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52F988-60F2-4B04-946D-EDDCC1C49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954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8A28B4-9C53-48A6-B25C-8A318DBBFC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2CBDB4-315D-4684-B7F7-C80DDD430B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3A117F-B099-4386-AB99-09432A317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0096AE-3F68-4C07-B0A7-14A5589D1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9296F5-25CF-46C1-BA42-B164AE724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622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3B6A24-991C-46D3-8647-EC3EBD685A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1F4424-0F5B-432A-AEFB-6A505045E2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62287C-D9EA-4CD9-BA1A-8FA22F700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DBB545-F275-4D33-93DA-5B37EDF6C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5A8BF6-4AC9-4129-B50A-94C5F668A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05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1115E-26E9-4AE9-A9A1-9F33D4670A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11DDF2-83AE-4D9D-8125-8074BC1D30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D3EBE1-1495-424B-8027-133C30BA6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F9B32-3190-44C3-8A61-0FFFA07BE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388CE0-4EF3-4197-B7B3-468EC445D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0014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F039A1-E1C0-4B29-98C5-155AD4366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8D4F80-3D28-4436-B23A-1E9C52D9BC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A88357-6DF9-4469-9B98-F5EFA212B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E9CF6-386C-4098-A15B-F537E9659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E38AD5-5FF9-4D04-9F13-7160C14C7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3057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8E122-2059-4C93-A719-B79E53E80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23F92B-1EF7-4D7A-A21B-AC52FF4DC3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8B96F1-E21E-4980-AD28-4381BA0182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29C78A-3842-4BD3-BC1F-81005976B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927ACA-8069-4D87-9CBE-5E2F1C16F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201CFF-BB7C-4A4A-BEA9-CC3779367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19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AF2C24-CAE4-44CB-8061-6E6303F37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9F0ACB-7BBC-4AE9-AA06-D0BDD54FE5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5E7C58-22B7-4824-B0B3-727F5156AC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A2332C-F23D-466E-B856-A7C86A3337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F93030-0502-47FF-A7FD-B919FA9B16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02DBA8-9302-4C19-B18A-3D3A40545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E9788A-CBF9-467A-ACB4-85461C52A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374F26-6319-4AE6-8DEA-41568A41D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591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F6C229-F32B-4FB6-A7EA-EEEDA6F2C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265A83-5D28-4184-9E97-D69E10FA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2871F7-DC64-432C-A2AD-87E1FDCE1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CF1CFDA-BACB-4860-B786-314919623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390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F79511-364E-490C-9BA2-4EE978A80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050D52-173F-4982-B9AF-650149659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D6A47C-3599-4FDF-B162-D60390A05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360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F41AE-09DA-4D73-B8C1-8A18D5E537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804030-B005-4BF2-87D4-8F7DC59D83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DA1980-9533-49E0-ABAF-063B5275B6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7537D5-D8E3-4EB5-B62E-3957168EC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581A18-7410-4101-8C63-A896AC1A3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358996-3D97-4025-B1CF-1990A6A35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7334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2A5F4-FAEE-4204-A120-645A392E08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958F26-656D-4D93-9BD0-9D97862502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0610CB-7E52-49A8-A659-AE51AF73CA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B091F1-44B1-4210-B218-43FA8523B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A24116-099C-45BE-B3C7-4557EDEC1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22C4CB-E308-4CAF-915A-8A17AA267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7390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4AF2DE-04B1-4E2D-A5F0-62A42326CE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BD6CF8-9571-441D-B1E7-4A2476E091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DE1A56-1344-41EE-9768-4583C92B3C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39DCB-D8F5-4F3B-9D2E-327CCC4C1632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8FFE58-5B61-4131-AB4A-165F91DA57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1461A-692A-483F-9660-35B2AA80DE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98D62-6993-44B8-B06E-08519C9299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0632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36F67D5-45A6-40DD-9905-C3C92471A4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4517495"/>
              </p:ext>
            </p:extLst>
          </p:nvPr>
        </p:nvGraphicFramePr>
        <p:xfrm>
          <a:off x="0" y="390684"/>
          <a:ext cx="7449820" cy="5709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C3BAC741-7CBD-4D43-8264-AD6B7B3F1118}"/>
              </a:ext>
            </a:extLst>
          </p:cNvPr>
          <p:cNvSpPr/>
          <p:nvPr/>
        </p:nvSpPr>
        <p:spPr>
          <a:xfrm>
            <a:off x="121920" y="0"/>
            <a:ext cx="11907520" cy="3906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line Resource Figure 1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asma-to-blood ratio for each patient</a:t>
            </a:r>
            <a:endParaRPr lang="en-GB" b="1" dirty="0">
              <a:latin typeface="Times New Roman Bold" panose="020208030705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5FB7CD6-D9D5-4F51-AA9D-0F628F88828D}"/>
              </a:ext>
            </a:extLst>
          </p:cNvPr>
          <p:cNvSpPr/>
          <p:nvPr/>
        </p:nvSpPr>
        <p:spPr>
          <a:xfrm>
            <a:off x="214630" y="6057781"/>
            <a:ext cx="11762740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inetic analysis and optimization of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8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-rhPSMA-7.3 PET imaging of prostate cancer. EJNMMI.</a:t>
            </a:r>
          </a:p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mona Malaspina, Vesa Oikonen, Anna Kuisma, Otto Ettala, Kalle Mattila, Peter J.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ström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Heikki Minn, Kari Kalliokoski, Ernst J. Postema, Matthew P. Miller, and Mika Scheinin.</a:t>
            </a:r>
          </a:p>
          <a:p>
            <a:pPr algn="just">
              <a:spcBef>
                <a:spcPts val="600"/>
              </a:spcBef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rresponding author: Simona Malaspina (simona.malaspina@tyks.fi)</a:t>
            </a:r>
          </a:p>
        </p:txBody>
      </p:sp>
    </p:spTree>
    <p:extLst>
      <p:ext uri="{BB962C8B-B14F-4D97-AF65-F5344CB8AC3E}">
        <p14:creationId xmlns:p14="http://schemas.microsoft.com/office/powerpoint/2010/main" val="4091561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312B4FDAE1D541A5F30E6BB9B86D49" ma:contentTypeVersion="12" ma:contentTypeDescription="Create a new document." ma:contentTypeScope="" ma:versionID="773b2be10ec5227a9a48ab12fbdb2f21">
  <xsd:schema xmlns:xsd="http://www.w3.org/2001/XMLSchema" xmlns:xs="http://www.w3.org/2001/XMLSchema" xmlns:p="http://schemas.microsoft.com/office/2006/metadata/properties" xmlns:ns3="3ab763a9-f395-4362-a7e8-caed2f9a57bf" xmlns:ns4="c3269ce3-b048-4fc4-a974-89a94645a580" targetNamespace="http://schemas.microsoft.com/office/2006/metadata/properties" ma:root="true" ma:fieldsID="0ba40fd1b96ccc01bc5e264525ca5981" ns3:_="" ns4:_="">
    <xsd:import namespace="3ab763a9-f395-4362-a7e8-caed2f9a57bf"/>
    <xsd:import namespace="c3269ce3-b048-4fc4-a974-89a94645a580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ab763a9-f395-4362-a7e8-caed2f9a57b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3269ce3-b048-4fc4-a974-89a94645a58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CFD96F1-342B-4BA3-A75C-7FB09BE0B2B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ab763a9-f395-4362-a7e8-caed2f9a57bf"/>
    <ds:schemaRef ds:uri="c3269ce3-b048-4fc4-a974-89a94645a58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4A3EAB9-61DB-4A56-8F91-B2735D4B2116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c3269ce3-b048-4fc4-a974-89a94645a580"/>
    <ds:schemaRef ds:uri="3ab763a9-f395-4362-a7e8-caed2f9a57bf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4ECC1E29-AF3F-4257-93AD-1D430BA5041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85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 Bold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riona</dc:creator>
  <cp:lastModifiedBy>Simona Malaspina</cp:lastModifiedBy>
  <cp:revision>5</cp:revision>
  <dcterms:created xsi:type="dcterms:W3CDTF">2021-02-25T20:24:45Z</dcterms:created>
  <dcterms:modified xsi:type="dcterms:W3CDTF">2021-03-27T16:41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312B4FDAE1D541A5F30E6BB9B86D49</vt:lpwstr>
  </property>
</Properties>
</file>